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9" r:id="rId3"/>
    <p:sldId id="261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8" y="94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notesMaster" Target="notesMasters/notesMaster1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0B1817-B3C2-4260-9E13-C6E54D87A33E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074BFB-3304-4F2B-80F5-0D8D439A8047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4507C-2C59-4EEE-9108-4A1BD2CF317A}" type="datetimeFigureOut">
              <a:rPr lang="en-AU" smtClean="0"/>
              <a:pPr/>
              <a:t>9/0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E78D5-5040-4510-98A4-D2D7DB60A927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172531"/>
            <a:ext cx="5904656" cy="8863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UPPLEMENTARY DATA</a:t>
            </a:r>
            <a:endParaRPr lang="en-AU" sz="1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100" b="1" dirty="0" smtClean="0"/>
              <a:t> </a:t>
            </a:r>
            <a:endParaRPr lang="en-AU" sz="1100" dirty="0" smtClean="0"/>
          </a:p>
          <a:p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Supplemental Text 1. Sequences used as probe in northern blot hybridization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endParaRPr lang="en-AU" sz="1100" b="1" i="1" dirty="0" smtClean="0"/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GUS mRNA probe</a:t>
            </a:r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AU" sz="1200" i="1" dirty="0" smtClean="0">
                <a:latin typeface="Times New Roman" pitchFamily="18" charset="0"/>
                <a:cs typeface="Times New Roman" pitchFamily="18" charset="0"/>
              </a:rPr>
              <a:t>in vitro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transcript of the complementary sequence was used as probe</a:t>
            </a:r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: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5’ACCGTGGTGACGCATGTCGCGCAAGACTGTAACCACGCGTCTGTTGACTGGCAGGTGGTGGCCAATGGTGATGTCAGCGTTGAACTGCGTGATGCGGATCAACAGGTGGTTGCAACTGGACAAGGCACTAGCGGGACTTTGCAAGTGGTGAATCCGCACCTCTGGCAACCGGGTGAAGGTTATCTCTATGAACTGTGCGTCACAGCCAAAAGCCAGACAGAGTGT</a:t>
            </a:r>
          </a:p>
          <a:p>
            <a:r>
              <a:rPr lang="en-AU" sz="1100" dirty="0" smtClean="0"/>
              <a:t> </a:t>
            </a:r>
          </a:p>
          <a:p>
            <a:r>
              <a:rPr lang="en-AU" sz="1200" b="1" i="1" dirty="0" err="1" smtClean="0">
                <a:latin typeface="Times New Roman" pitchFamily="18" charset="0"/>
                <a:cs typeface="Times New Roman" pitchFamily="18" charset="0"/>
              </a:rPr>
              <a:t>hpGUS</a:t>
            </a:r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 loop probe</a:t>
            </a:r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AU" sz="1200" i="1" dirty="0" smtClean="0">
                <a:latin typeface="Times New Roman" pitchFamily="18" charset="0"/>
                <a:cs typeface="Times New Roman" pitchFamily="18" charset="0"/>
              </a:rPr>
              <a:t>in vitro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transcript of the complementary sequence was used as probe):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5’GATATCACCGTGGTGACGCATGTCGCGCAAGACTGTAACCACGCGTCTGTTGACTGGCAGGTGGTGGCCAATGGTGATGTCAGCGTTGAACTGCGTGATGCGGATCAACAGGTGGTTGCAACTGGACAAGGCACTAGCGGGACTTTGCAAGTGGTGAATCCGCACCTCTGGCAACCGGGTGAAGGTTATCTCTATGAACTGTGCGTCACAGCCAAAAGCCAGACAGAGTGTGATATCTACCCGCTTCGCGTCGGCATCCGGTCAGTGGCAGTGAAGGGCGAACAGTTCCTGATTAACCACAAACCGTTCTACTTTACTGGCTTTGGTCGTCATGAAGATGCGGACTTGCGTGGCAAAGGATTCGATAACGTGCTGATGGTGCACGACCACGCATTAATGGACTGGATTGGGGCCAACTCCTACCGTACCTCGCATTACCCTTACGCTGAAGAGATGCTCGACTGGGCAGATGAACATGGCATCGTGGTGATTGATGAAACTGCTGCTGTCGGCTTTAACCTCTCTTTAGGCATTGGTTTCGAAGCGGGCAACAAGCCGAAAGAACTGTACAGCGAAGAGGCAGTCAACGGGGAAACTCAGCAAGCGCACTTACAGGCGATTAAAGAGCTGATAGCGCGTGACAAAAACCACCCAAGCGTGGTGATGTGGAGTATTGCCAACGAACCGGATACCCGTCCGCAAGGTGCACGGGAATATTTCGCGCCACTGGCGGAAGCAACGCGTAAACTCGACCCGACGCGTCCGATCACCTGCGTCAATGTAATGTTCTGCGACGCTCACACCGATACCATCAGCGATCTCTTTGATGTGCTGTGCCTGAACCGTTATTACGGATGGTATGTCCAAAGCGGCGATTTGGAAACGGCAGAGAAGGTACTGGAAAAAGAACTTCTGGCCTGGCAGGAGAAACTGCATCAGCCGATTATCATCACCGAATACGGCGTGGATACGTTAGCCGGGCTGCACTCAATGTACACCGACATGTGGAGTGAAGAGTATCAGTGTGCATGGCTGGATATGTATCACCGCGTCTTTGATCGCGTCAGCGCCGTCGTCGGTGAACAGGTATGGAATTTCGCCGATTTTGCGACCTCGCAAGGCATATTGCGCGTTGGCGGTAACAAGAAAGGGATCTTCACTCGCGACCGCAAACCGAAGTCGGCGGCTTTTCTGCTGCAAAAACGCTGGACTGGCATGAACTTCGGTGAAAAACCGCAGCAGGGAGGCAAACAATGAATCAACAACTCTCCTGGCGCACCATCGTCGGCTACAGCCTCGGGAATT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 </a:t>
            </a: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CMV RNA 3a probe</a:t>
            </a:r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AU" sz="1200" i="1" dirty="0" smtClean="0">
                <a:latin typeface="Times New Roman" pitchFamily="18" charset="0"/>
                <a:cs typeface="Times New Roman" pitchFamily="18" charset="0"/>
              </a:rPr>
              <a:t>in vitro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transcript of the complementary sequence was used as probe):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5’AAGTAACCCACGGTCGTATTGCTTCCTTCTTTAAGTCTGGATATGATGTTGGTGAATTATGCTCAAAAGGATACATGAGTGTCCCTCAAGTGTTATGTGCTGTTACTCGAACAGTTTCCACTGATGCTGAAGGGTCTTTGAGAATTTACTTAGCTGATCTGGGCGACAAGGAGTTATCTCCCATAGATGGGCAATGCGTTTCGTTACATAACCATGATCTTCCCGCTTTGGTGTCTTTCCAACCGACGTATGATTGTCCTATGGAAACAGTTGGGAATCGTAAGCGGTGTTTTGCTGTCGTTATCGAAAGACATGGTTACATTGGGTATACCGGTACCACAGCTAGCGTGTGTAGTAATTGGCAAGCAAGGTTTTCATCCAAGAATAACAACTACACTCATATCGCAGCTGGGAAGACTCTAGTACTGCCTTTCAACAGATTAGCTGAGCAAACAAAACCGTCAGCTGTCGCTCGCCTGTTGAAGTCGCAATT</a:t>
            </a:r>
          </a:p>
          <a:p>
            <a:r>
              <a:rPr lang="en-AU" sz="1100" dirty="0" smtClean="0"/>
              <a:t> </a:t>
            </a: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Y-Satellite RNA probe</a:t>
            </a:r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AU" sz="1200" i="1" dirty="0" smtClean="0">
                <a:latin typeface="Times New Roman" pitchFamily="18" charset="0"/>
                <a:cs typeface="Times New Roman" pitchFamily="18" charset="0"/>
              </a:rPr>
              <a:t>in vitro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transcript of the complementary sequence was used as probe):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5’GTTTTGTTTGATGGAGAATTGCGTAGAGGGGTTATATCTGCGTGAGGATCCATCACTCGGCGGTGTGGGATACCTCCCTGCTAAGGCGGGTTGAGAGTGTATCTCGGACTGGAGGCGGGATGTCTGCGGGTGTTCCGTCTGCTGCCCACGATGGTGGGAGTCACCCAAGGGGTGACTTTTTCAGCTCTGCATTTCTCATTTGAGCCCCCGCTCAGTTTGCTAGCAAAACCCGGCACATGGTTCGCCGTTACTATGGATTTCGAAAGAAACACTCTGTTAGGTGGTATCGTGGATGACGCACGCAGGGGGAAGCTAAGGCTTATGCTATGCTGATCTCCGTGAATGTCTATACATTCCTCTACAGGACCC</a:t>
            </a:r>
          </a:p>
          <a:p>
            <a:endParaRPr lang="en-AU" sz="11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2696" y="251521"/>
            <a:ext cx="5688632" cy="8448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GUS </a:t>
            </a:r>
            <a:r>
              <a:rPr lang="en-AU" sz="1200" b="1" i="1" dirty="0" err="1" smtClean="0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 probe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AU" sz="1200" dirty="0" err="1" smtClean="0">
                <a:latin typeface="Times New Roman" pitchFamily="18" charset="0"/>
                <a:cs typeface="Times New Roman" pitchFamily="18" charset="0"/>
              </a:rPr>
              <a:t>hpGUS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stem):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5’GTCCACCCAGGTGTTCGGCGTGGTGTAGAGCATTACGCTGCGATGGATTCCGGCATAGTTAAAGAAATCATGGAAGTAAGACTGCTTTTTCTTGCCGTTTTCGTCGGTAATCACCATTCCCGGCGGGATAGTCTGCCAGTTCAGTTCGTTGTTCACACAAACGGTGATACGTACACTTTTCCCGGCAATAACATACGGCGTGACATCGGCTTCAAATGGCGTATAGCCGCCCTGATGCTCCATCACTTCCTGATTATTGACCCACACTTTGCCGTAATGAGTGACCGCATCGAAACGCAGCACGATACGCTGGCCTGCCCAACCTTTCGGTATAAAGACTTCGCGCTGATACCAGACGTTGCCCGCATAATTACGAATATCTGCATCGGCGAACTGATCGTTAAAACTGCCTGGCACAGCAATTGCCCGGCTTTCTTGTAACGCGCTTTCCCACCAACGCTGATCAATTCCACAGTTTTCGCGATCCAGACTGAATGCCCACAGGCCGTCGAGTTTTTTGATTTCACGGGTTGGGGTTTCTACAGGACGTAACAT </a:t>
            </a:r>
          </a:p>
          <a:p>
            <a:r>
              <a:rPr lang="en-AU" sz="1400" b="1" dirty="0" smtClean="0"/>
              <a:t> </a:t>
            </a:r>
            <a:endParaRPr lang="en-AU" sz="1400" dirty="0" smtClean="0"/>
          </a:p>
          <a:p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Supplemental Text 2. </a:t>
            </a:r>
            <a:r>
              <a:rPr lang="en-AU" sz="1200" b="1" dirty="0" err="1" smtClean="0">
                <a:latin typeface="Times New Roman" pitchFamily="18" charset="0"/>
                <a:cs typeface="Times New Roman" pitchFamily="18" charset="0"/>
              </a:rPr>
              <a:t>Oligonucleotide</a:t>
            </a:r>
            <a:r>
              <a:rPr lang="en-AU" sz="1200" b="1" dirty="0" smtClean="0">
                <a:latin typeface="Times New Roman" pitchFamily="18" charset="0"/>
                <a:cs typeface="Times New Roman" pitchFamily="18" charset="0"/>
              </a:rPr>
              <a:t> primers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400" dirty="0" smtClean="0"/>
              <a:t> </a:t>
            </a:r>
            <a:endParaRPr lang="en-AU" sz="1400" dirty="0" smtClean="0"/>
          </a:p>
          <a:p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Primers for detecting mRNA of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agroinfiltrated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 2b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transgen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100" dirty="0" smtClean="0">
                <a:latin typeface="Courier New" pitchFamily="49" charset="0"/>
                <a:cs typeface="Courier New" pitchFamily="49" charset="0"/>
              </a:rPr>
              <a:t>2b-F4: 5’-CCATGATTTCGACGATACGG</a:t>
            </a:r>
            <a:endParaRPr lang="en-AU" sz="11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100" dirty="0" smtClean="0">
                <a:latin typeface="Courier New" pitchFamily="49" charset="0"/>
                <a:cs typeface="Courier New" pitchFamily="49" charset="0"/>
              </a:rPr>
              <a:t>Nos-R2: 5’-GCAACAGGATTCAATCTTAAG</a:t>
            </a:r>
            <a:endParaRPr lang="en-AU" sz="11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400" dirty="0" smtClean="0"/>
              <a:t> </a:t>
            </a:r>
            <a:endParaRPr lang="en-AU" sz="1400" dirty="0" smtClean="0"/>
          </a:p>
          <a:p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Primers for detecting mRNA of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HcPro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transgene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100" dirty="0" err="1" smtClean="0">
                <a:latin typeface="Courier New" pitchFamily="49" charset="0"/>
                <a:cs typeface="Courier New" pitchFamily="49" charset="0"/>
              </a:rPr>
              <a:t>HcPro</a:t>
            </a:r>
            <a:r>
              <a:rPr lang="en-US" sz="1100" dirty="0" smtClean="0">
                <a:latin typeface="Courier New" pitchFamily="49" charset="0"/>
                <a:cs typeface="Courier New" pitchFamily="49" charset="0"/>
              </a:rPr>
              <a:t>-F: 5’-</a:t>
            </a:r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CACTCAATGACACATTATAG</a:t>
            </a:r>
          </a:p>
          <a:p>
            <a:r>
              <a:rPr lang="en-AU" sz="1100" dirty="0" err="1" smtClean="0">
                <a:latin typeface="Courier New" pitchFamily="49" charset="0"/>
                <a:cs typeface="Courier New" pitchFamily="49" charset="0"/>
              </a:rPr>
              <a:t>HcPro</a:t>
            </a:r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-R: 5’-CTTGCTATTTCAAGCATATGTG</a:t>
            </a:r>
          </a:p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 </a:t>
            </a: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Primers for amplifyi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EF1α mRNA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100" dirty="0" smtClean="0">
                <a:latin typeface="Courier New" pitchFamily="49" charset="0"/>
                <a:cs typeface="Courier New" pitchFamily="49" charset="0"/>
              </a:rPr>
              <a:t>EF1α-F: 5’-TGGTCATTGGCCACGTCGACTC</a:t>
            </a:r>
            <a:endParaRPr lang="en-AU" sz="11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100" dirty="0" smtClean="0">
                <a:latin typeface="Courier New" pitchFamily="49" charset="0"/>
                <a:cs typeface="Courier New" pitchFamily="49" charset="0"/>
              </a:rPr>
              <a:t>EF1α-R: 5’-ACCGCTTGTGCATCTCAGCAGC</a:t>
            </a:r>
            <a:endParaRPr lang="en-AU" sz="11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Primers for amplifyi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miR156 target mRNA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(ET047334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56-F: 5’-GCCAATTATTCTGGTCCTGG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56-R: 5’-GCTAGAGGATTGGTTCCTCGAG</a:t>
            </a: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Primers for amplifyi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miR160 target mRNA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(FH226342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60-F1: 5’-CCTCAGGTCCAGCAGTCC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60-R1: 5’-TCCCGATTGCACTTTGTTGC </a:t>
            </a:r>
          </a:p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 </a:t>
            </a: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Primers for amplifyi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miR168 target mRNA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(FG138554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68-F: 5’-ACTCAGCAGTATCAACGAGG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68-R: 5’-CATATGGTACAGGCTGATGC</a:t>
            </a:r>
          </a:p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 </a:t>
            </a: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Primers for amplifyi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miR172 target mRNA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(FH976844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72-F: 5’-GAAGCAACTTCTTCTCCAGG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172-R: 5’-GTGTTCGGATACAGAGTGG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200" b="1" i="1" dirty="0" smtClean="0">
                <a:latin typeface="Times New Roman" pitchFamily="18" charset="0"/>
                <a:cs typeface="Times New Roman" pitchFamily="18" charset="0"/>
              </a:rPr>
              <a:t>Primers for amplifyi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miR395 target mRNA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 (ET937275)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</a:t>
            </a:r>
            <a:endParaRPr lang="en-AU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395-F: 5’-CTTGAGTCAGCAACTGTCCC</a:t>
            </a:r>
          </a:p>
          <a:p>
            <a:r>
              <a:rPr lang="en-AU" sz="1100" dirty="0" smtClean="0">
                <a:latin typeface="Courier New" pitchFamily="49" charset="0"/>
                <a:cs typeface="Courier New" pitchFamily="49" charset="0"/>
              </a:rPr>
              <a:t>TmiR395-R: 5’-TTTATTTAACAGGAGTTTTAGGC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100" dirty="0" smtClean="0">
              <a:latin typeface="Courier New" pitchFamily="49" charset="0"/>
              <a:cs typeface="Courier New" pitchFamily="49" charset="0"/>
            </a:endParaRPr>
          </a:p>
          <a:p>
            <a:endParaRPr lang="en-AU" sz="11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4624" y="1941479"/>
            <a:ext cx="6776138" cy="2191733"/>
            <a:chOff x="44624" y="1941479"/>
            <a:chExt cx="6776138" cy="2191733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50873" y="3346615"/>
              <a:ext cx="5982203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750873" y="2914567"/>
              <a:ext cx="5976664" cy="3630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50873" y="3779912"/>
              <a:ext cx="5976664" cy="353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" name="TextBox 5"/>
            <p:cNvSpPr txBox="1"/>
            <p:nvPr/>
          </p:nvSpPr>
          <p:spPr>
            <a:xfrm>
              <a:off x="422242" y="2974440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i="1" dirty="0" smtClean="0">
                  <a:latin typeface="Arial" pitchFamily="34" charset="0"/>
                  <a:cs typeface="Arial" pitchFamily="34" charset="0"/>
                </a:rPr>
                <a:t>2b</a:t>
              </a:r>
              <a:endParaRPr lang="en-AU" sz="12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78226" y="3406488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EF-</a:t>
              </a:r>
              <a:r>
                <a:rPr lang="el-GR" sz="1200" dirty="0" smtClean="0">
                  <a:latin typeface="Arial" pitchFamily="34" charset="0"/>
                  <a:cs typeface="Arial" pitchFamily="34" charset="0"/>
                </a:rPr>
                <a:t>α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624" y="3818013"/>
              <a:ext cx="93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-RT (</a:t>
              </a:r>
              <a:r>
                <a:rPr lang="en-AU" sz="1200" i="1" dirty="0" smtClean="0">
                  <a:latin typeface="Arial" pitchFamily="34" charset="0"/>
                  <a:cs typeface="Arial" pitchFamily="34" charset="0"/>
                </a:rPr>
                <a:t>2b</a:t>
              </a:r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381328" y="2688744"/>
              <a:ext cx="4394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 err="1" smtClean="0">
                  <a:latin typeface="Arial" pitchFamily="34" charset="0"/>
                  <a:cs typeface="Arial" pitchFamily="34" charset="0"/>
                </a:rPr>
                <a:t>Ve</a:t>
              </a:r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08945" y="268977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162736" y="26897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11084" y="26897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870326" y="26897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224117" y="26897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572465" y="268975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6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942597" y="26897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7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296388" y="26897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8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644736" y="268975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9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944101" y="268975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303343" y="2689763"/>
              <a:ext cx="3431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1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646248" y="268975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2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010925" y="268975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3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370171" y="268976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4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707633" y="268975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5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066867" y="268975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16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29373" y="24694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166835" y="2469432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526069" y="2469428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885303" y="246942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233651" y="246942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560243" y="24857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930363" y="248576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305934" y="2469432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643396" y="2469428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002630" y="246942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361864" y="246942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710212" y="246941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406928" y="248576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738947" y="2485758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103624" y="248575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069446" y="2469412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829369" y="2235383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166831" y="2235379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526065" y="2235375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858092" y="225171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211883" y="225170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560235" y="225170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24912" y="2251705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300487" y="2235379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637949" y="2235375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997183" y="2235371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334653" y="225170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683001" y="2251705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031353" y="2251705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396030" y="225170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733500" y="2251705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098177" y="225170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54463" y="2284381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Q-CMV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95977" y="2502095"/>
              <a:ext cx="5552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>
                  <a:latin typeface="Arial" pitchFamily="34" charset="0"/>
                  <a:cs typeface="Arial" pitchFamily="34" charset="0"/>
                </a:rPr>
                <a:t>Y-Sat</a:t>
              </a:r>
              <a:endParaRPr lang="en-AU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0" name="Straight Connector 59"/>
            <p:cNvCxnSpPr/>
            <p:nvPr/>
          </p:nvCxnSpPr>
          <p:spPr>
            <a:xfrm>
              <a:off x="894688" y="2251724"/>
              <a:ext cx="226422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 flipV="1">
              <a:off x="3382135" y="2251701"/>
              <a:ext cx="2887688" cy="1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1449858" y="1941479"/>
              <a:ext cx="9765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GUS + 2b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920909" y="1946922"/>
              <a:ext cx="17684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GUS + </a:t>
              </a:r>
              <a:r>
                <a:rPr lang="en-AU" sz="1400" dirty="0" err="1" smtClean="0">
                  <a:latin typeface="Arial" pitchFamily="34" charset="0"/>
                  <a:cs typeface="Arial" pitchFamily="34" charset="0"/>
                </a:rPr>
                <a:t>hpGUS</a:t>
              </a:r>
              <a:r>
                <a:rPr lang="en-AU" sz="1400" dirty="0" smtClean="0">
                  <a:latin typeface="Arial" pitchFamily="34" charset="0"/>
                  <a:cs typeface="Arial" pitchFamily="34" charset="0"/>
                </a:rPr>
                <a:t> + 2b</a:t>
              </a:r>
              <a:endParaRPr lang="en-AU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4" name="TextBox 63"/>
          <p:cNvSpPr txBox="1"/>
          <p:nvPr/>
        </p:nvSpPr>
        <p:spPr>
          <a:xfrm>
            <a:off x="495300" y="4739640"/>
            <a:ext cx="622554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>
                <a:latin typeface="Times New Roman" pitchFamily="18" charset="0"/>
                <a:cs typeface="Times New Roman" pitchFamily="18" charset="0"/>
              </a:rPr>
              <a:t>Supplemental Figure S1. 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Semi-quantitative RT-PCR analysis of 2b expression levels in </a:t>
            </a:r>
            <a:r>
              <a:rPr lang="en-AU" sz="1400" dirty="0" err="1" smtClean="0">
                <a:latin typeface="Times New Roman" pitchFamily="18" charset="0"/>
                <a:cs typeface="Times New Roman" pitchFamily="18" charset="0"/>
              </a:rPr>
              <a:t>agroinfiltrated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400" i="1" dirty="0" smtClean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AU" sz="1400" i="1" dirty="0" err="1" smtClean="0">
                <a:latin typeface="Times New Roman" pitchFamily="18" charset="0"/>
                <a:cs typeface="Times New Roman" pitchFamily="18" charset="0"/>
              </a:rPr>
              <a:t>benthamiana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 tissue. </a:t>
            </a:r>
          </a:p>
          <a:p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Primers used (Supplemental Text 2) only amplify the 2b mRNA from the agro-infiltrated 2b </a:t>
            </a:r>
            <a:r>
              <a:rPr lang="en-AU" sz="1400" dirty="0" err="1" smtClean="0">
                <a:latin typeface="Times New Roman" pitchFamily="18" charset="0"/>
                <a:cs typeface="Times New Roman" pitchFamily="18" charset="0"/>
              </a:rPr>
              <a:t>transgene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 but not the 2b RNA from infecting CMV.</a:t>
            </a:r>
            <a:r>
              <a:rPr lang="en-AU" sz="1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The elongation factor 1α gene (EF1α) was amplified for use as loading control. PCR was performed with 25 cycles, with an annealing temperature of 56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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C for both 2b and EF1α. The bottom panel is reverse transcriptase-minus RT-PCR control. </a:t>
            </a:r>
            <a:r>
              <a:rPr lang="en-AU" sz="1400" dirty="0" err="1" smtClean="0">
                <a:latin typeface="Times New Roman" pitchFamily="18" charset="0"/>
                <a:cs typeface="Times New Roman" pitchFamily="18" charset="0"/>
              </a:rPr>
              <a:t>Ve</a:t>
            </a:r>
            <a:r>
              <a:rPr lang="en-AU" sz="1400" dirty="0" smtClean="0">
                <a:latin typeface="Times New Roman" pitchFamily="18" charset="0"/>
                <a:cs typeface="Times New Roman" pitchFamily="18" charset="0"/>
              </a:rPr>
              <a:t>-, water control. Note that the 2b expression level is not significantly affected by Q-CMV or Q-CMV+Y-Sat infection. </a:t>
            </a:r>
          </a:p>
          <a:p>
            <a:endParaRPr lang="en-AU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314336D5B64B243929ABF7A6F2042C3" ma:contentTypeVersion="7" ma:contentTypeDescription="Create a new document." ma:contentTypeScope="" ma:versionID="fcfc8e5995a43021ae4cbe819a0dac15">
  <xsd:schema xmlns:xsd="http://www.w3.org/2001/XMLSchema" xmlns:p="http://schemas.microsoft.com/office/2006/metadata/properties" xmlns:ns2="0ee220af-f9d7-4c7f-8433-50fb4088673f" targetNamespace="http://schemas.microsoft.com/office/2006/metadata/properties" ma:root="true" ma:fieldsID="78890a358360b9fb23cfa529a447f4d9" ns2:_="">
    <xsd:import namespace="0ee220af-f9d7-4c7f-8433-50fb4088673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ee220af-f9d7-4c7f-8433-50fb4088673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0ee220af-f9d7-4c7f-8433-50fb4088673f">
      <UserInfo>
        <DisplayName/>
        <AccountId xsi:nil="true"/>
        <AccountType/>
      </UserInfo>
    </Checked_x0020_Out_x0020_To>
    <IsDeleted xmlns="0ee220af-f9d7-4c7f-8433-50fb4088673f">false</IsDeleted>
    <FileFormat xmlns="0ee220af-f9d7-4c7f-8433-50fb4088673f">PPTX</FileFormat>
    <DocumentType xmlns="0ee220af-f9d7-4c7f-8433-50fb4088673f">Presentation</DocumentType>
    <DocumentId xmlns="0ee220af-f9d7-4c7f-8433-50fb4088673f">Presentation 1.PPTX</DocumentId>
    <TitleName xmlns="0ee220af-f9d7-4c7f-8433-50fb4088673f">Presentation 1.PPTX</TitleName>
    <StageName xmlns="0ee220af-f9d7-4c7f-8433-50fb4088673f" xsi:nil="true"/>
  </documentManagement>
</p:properties>
</file>

<file path=customXml/itemProps1.xml><?xml version="1.0" encoding="utf-8"?>
<ds:datastoreItem xmlns:ds="http://schemas.openxmlformats.org/officeDocument/2006/customXml" ds:itemID="{C0492215-DF20-4606-A09D-AFD9E63D5704}"/>
</file>

<file path=customXml/itemProps2.xml><?xml version="1.0" encoding="utf-8"?>
<ds:datastoreItem xmlns:ds="http://schemas.openxmlformats.org/officeDocument/2006/customXml" ds:itemID="{65A33D2C-65A4-4CA1-9297-217C6D2E8D68}"/>
</file>

<file path=customXml/itemProps3.xml><?xml version="1.0" encoding="utf-8"?>
<ds:datastoreItem xmlns:ds="http://schemas.openxmlformats.org/officeDocument/2006/customXml" ds:itemID="{209DCB10-714C-4486-A853-C7FE0BC46E27}"/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88</Words>
  <Application>Microsoft Office PowerPoint</Application>
  <PresentationFormat>On-screen Show (4:3)</PresentationFormat>
  <Paragraphs>110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CSIR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ang, Ming-Bo (PI, Black Mountain)</dc:creator>
  <cp:lastModifiedBy>Wang, Ming-Bo (Agriculture, Black Mountain)</cp:lastModifiedBy>
  <cp:revision>21</cp:revision>
  <dcterms:created xsi:type="dcterms:W3CDTF">2012-08-14T05:49:54Z</dcterms:created>
  <dcterms:modified xsi:type="dcterms:W3CDTF">2015-01-09T04:41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314336D5B64B243929ABF7A6F2042C3</vt:lpwstr>
  </property>
</Properties>
</file>